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59B42AE-FF30-483C-8862-A36516484D75}" v="1" dt="2021-10-11T13:19:12.76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725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emanueleci hotmail.it" userId="e89a963879081f48" providerId="LiveId" clId="{859B42AE-FF30-483C-8862-A36516484D75}"/>
    <pc:docChg chg="undo custSel addSld delSld modSld">
      <pc:chgData name="emanueleci hotmail.it" userId="e89a963879081f48" providerId="LiveId" clId="{859B42AE-FF30-483C-8862-A36516484D75}" dt="2021-10-19T12:10:14.505" v="562" actId="20577"/>
      <pc:docMkLst>
        <pc:docMk/>
      </pc:docMkLst>
      <pc:sldChg chg="new del">
        <pc:chgData name="emanueleci hotmail.it" userId="e89a963879081f48" providerId="LiveId" clId="{859B42AE-FF30-483C-8862-A36516484D75}" dt="2021-10-11T13:19:14.997" v="2" actId="47"/>
        <pc:sldMkLst>
          <pc:docMk/>
          <pc:sldMk cId="3257044230" sldId="256"/>
        </pc:sldMkLst>
      </pc:sldChg>
      <pc:sldChg chg="addSp delSp modSp add mod">
        <pc:chgData name="emanueleci hotmail.it" userId="e89a963879081f48" providerId="LiveId" clId="{859B42AE-FF30-483C-8862-A36516484D75}" dt="2021-10-19T12:10:14.505" v="562" actId="20577"/>
        <pc:sldMkLst>
          <pc:docMk/>
          <pc:sldMk cId="3950835867" sldId="257"/>
        </pc:sldMkLst>
        <pc:spChg chg="mod">
          <ac:chgData name="emanueleci hotmail.it" userId="e89a963879081f48" providerId="LiveId" clId="{859B42AE-FF30-483C-8862-A36516484D75}" dt="2021-10-19T12:09:28.037" v="540" actId="1037"/>
          <ac:spMkLst>
            <pc:docMk/>
            <pc:sldMk cId="3950835867" sldId="257"/>
            <ac:spMk id="4" creationId="{A42BFD2E-AC28-4C7A-9506-5456E9EEF41E}"/>
          </ac:spMkLst>
        </pc:spChg>
        <pc:spChg chg="mod">
          <ac:chgData name="emanueleci hotmail.it" userId="e89a963879081f48" providerId="LiveId" clId="{859B42AE-FF30-483C-8862-A36516484D75}" dt="2021-10-19T12:09:28.037" v="540" actId="1037"/>
          <ac:spMkLst>
            <pc:docMk/>
            <pc:sldMk cId="3950835867" sldId="257"/>
            <ac:spMk id="5" creationId="{81EAEBF6-1D89-4BBD-91AE-618237EC63AA}"/>
          </ac:spMkLst>
        </pc:spChg>
        <pc:spChg chg="mod">
          <ac:chgData name="emanueleci hotmail.it" userId="e89a963879081f48" providerId="LiveId" clId="{859B42AE-FF30-483C-8862-A36516484D75}" dt="2021-10-19T12:09:28.037" v="540" actId="1037"/>
          <ac:spMkLst>
            <pc:docMk/>
            <pc:sldMk cId="3950835867" sldId="257"/>
            <ac:spMk id="8" creationId="{2162AF28-BB35-464A-993B-2E62FF24715D}"/>
          </ac:spMkLst>
        </pc:spChg>
        <pc:spChg chg="mod">
          <ac:chgData name="emanueleci hotmail.it" userId="e89a963879081f48" providerId="LiveId" clId="{859B42AE-FF30-483C-8862-A36516484D75}" dt="2021-10-19T12:09:28.037" v="540" actId="1037"/>
          <ac:spMkLst>
            <pc:docMk/>
            <pc:sldMk cId="3950835867" sldId="257"/>
            <ac:spMk id="11" creationId="{A8AD9E5E-4582-4C2A-9F45-8E77747EA968}"/>
          </ac:spMkLst>
        </pc:spChg>
        <pc:spChg chg="mod">
          <ac:chgData name="emanueleci hotmail.it" userId="e89a963879081f48" providerId="LiveId" clId="{859B42AE-FF30-483C-8862-A36516484D75}" dt="2021-10-19T12:09:28.037" v="540" actId="1037"/>
          <ac:spMkLst>
            <pc:docMk/>
            <pc:sldMk cId="3950835867" sldId="257"/>
            <ac:spMk id="12" creationId="{E6597CF4-016B-4366-8883-E0C0B3363FFD}"/>
          </ac:spMkLst>
        </pc:spChg>
        <pc:spChg chg="mod">
          <ac:chgData name="emanueleci hotmail.it" userId="e89a963879081f48" providerId="LiveId" clId="{859B42AE-FF30-483C-8862-A36516484D75}" dt="2021-10-19T12:09:28.037" v="540" actId="1037"/>
          <ac:spMkLst>
            <pc:docMk/>
            <pc:sldMk cId="3950835867" sldId="257"/>
            <ac:spMk id="14" creationId="{C225EE38-EA76-4EA0-A9A2-56B5DBF896AD}"/>
          </ac:spMkLst>
        </pc:spChg>
        <pc:spChg chg="mod">
          <ac:chgData name="emanueleci hotmail.it" userId="e89a963879081f48" providerId="LiveId" clId="{859B42AE-FF30-483C-8862-A36516484D75}" dt="2021-10-19T12:09:28.037" v="540" actId="1037"/>
          <ac:spMkLst>
            <pc:docMk/>
            <pc:sldMk cId="3950835867" sldId="257"/>
            <ac:spMk id="18" creationId="{36FA1397-129F-4530-8186-71522C769539}"/>
          </ac:spMkLst>
        </pc:spChg>
        <pc:spChg chg="mod">
          <ac:chgData name="emanueleci hotmail.it" userId="e89a963879081f48" providerId="LiveId" clId="{859B42AE-FF30-483C-8862-A36516484D75}" dt="2021-10-19T12:09:28.037" v="540" actId="1037"/>
          <ac:spMkLst>
            <pc:docMk/>
            <pc:sldMk cId="3950835867" sldId="257"/>
            <ac:spMk id="19" creationId="{6DD693FF-8D0C-4FC3-B9B6-674F3ECF1E16}"/>
          </ac:spMkLst>
        </pc:spChg>
        <pc:spChg chg="mod">
          <ac:chgData name="emanueleci hotmail.it" userId="e89a963879081f48" providerId="LiveId" clId="{859B42AE-FF30-483C-8862-A36516484D75}" dt="2021-10-19T12:10:14.505" v="562" actId="20577"/>
          <ac:spMkLst>
            <pc:docMk/>
            <pc:sldMk cId="3950835867" sldId="257"/>
            <ac:spMk id="21" creationId="{A7119A6D-170B-4B36-99D4-8C6C803C57B9}"/>
          </ac:spMkLst>
        </pc:spChg>
        <pc:spChg chg="mod">
          <ac:chgData name="emanueleci hotmail.it" userId="e89a963879081f48" providerId="LiveId" clId="{859B42AE-FF30-483C-8862-A36516484D75}" dt="2021-10-19T12:09:28.037" v="540" actId="1037"/>
          <ac:spMkLst>
            <pc:docMk/>
            <pc:sldMk cId="3950835867" sldId="257"/>
            <ac:spMk id="23" creationId="{BEB0BD55-8E2B-4C50-B577-FA9531DAB4B0}"/>
          </ac:spMkLst>
        </pc:spChg>
        <pc:spChg chg="mod">
          <ac:chgData name="emanueleci hotmail.it" userId="e89a963879081f48" providerId="LiveId" clId="{859B42AE-FF30-483C-8862-A36516484D75}" dt="2021-10-19T12:10:04.729" v="549" actId="20577"/>
          <ac:spMkLst>
            <pc:docMk/>
            <pc:sldMk cId="3950835867" sldId="257"/>
            <ac:spMk id="24" creationId="{60A4D4A5-FB85-4C28-A698-F2701941E4BB}"/>
          </ac:spMkLst>
        </pc:spChg>
        <pc:spChg chg="del mod">
          <ac:chgData name="emanueleci hotmail.it" userId="e89a963879081f48" providerId="LiveId" clId="{859B42AE-FF30-483C-8862-A36516484D75}" dt="2021-10-19T12:08:44.894" v="489" actId="478"/>
          <ac:spMkLst>
            <pc:docMk/>
            <pc:sldMk cId="3950835867" sldId="257"/>
            <ac:spMk id="26" creationId="{5A6B647F-EB5D-46F1-9D95-D05A1E3EC7B8}"/>
          </ac:spMkLst>
        </pc:spChg>
        <pc:spChg chg="del mod">
          <ac:chgData name="emanueleci hotmail.it" userId="e89a963879081f48" providerId="LiveId" clId="{859B42AE-FF30-483C-8862-A36516484D75}" dt="2021-10-19T12:08:44.894" v="489" actId="478"/>
          <ac:spMkLst>
            <pc:docMk/>
            <pc:sldMk cId="3950835867" sldId="257"/>
            <ac:spMk id="27" creationId="{81B03917-DBC6-4078-8185-CE56FFF93CDD}"/>
          </ac:spMkLst>
        </pc:spChg>
        <pc:spChg chg="del mod">
          <ac:chgData name="emanueleci hotmail.it" userId="e89a963879081f48" providerId="LiveId" clId="{859B42AE-FF30-483C-8862-A36516484D75}" dt="2021-10-19T12:08:44.894" v="489" actId="478"/>
          <ac:spMkLst>
            <pc:docMk/>
            <pc:sldMk cId="3950835867" sldId="257"/>
            <ac:spMk id="29" creationId="{D0D86D2B-63A3-498C-B9D0-162AD27C9A57}"/>
          </ac:spMkLst>
        </pc:spChg>
        <pc:spChg chg="mod">
          <ac:chgData name="emanueleci hotmail.it" userId="e89a963879081f48" providerId="LiveId" clId="{859B42AE-FF30-483C-8862-A36516484D75}" dt="2021-10-19T12:09:45.745" v="547" actId="1076"/>
          <ac:spMkLst>
            <pc:docMk/>
            <pc:sldMk cId="3950835867" sldId="257"/>
            <ac:spMk id="31" creationId="{13AE9D6E-0A99-4C08-A5F5-77938EDABF18}"/>
          </ac:spMkLst>
        </pc:spChg>
        <pc:spChg chg="add del">
          <ac:chgData name="emanueleci hotmail.it" userId="e89a963879081f48" providerId="LiveId" clId="{859B42AE-FF30-483C-8862-A36516484D75}" dt="2021-10-19T12:08:26.373" v="484" actId="478"/>
          <ac:spMkLst>
            <pc:docMk/>
            <pc:sldMk cId="3950835867" sldId="257"/>
            <ac:spMk id="32" creationId="{3FDB359D-8E7A-4D70-A4E9-CE9C6CAB3989}"/>
          </ac:spMkLst>
        </pc:spChg>
        <pc:cxnChg chg="mod">
          <ac:chgData name="emanueleci hotmail.it" userId="e89a963879081f48" providerId="LiveId" clId="{859B42AE-FF30-483C-8862-A36516484D75}" dt="2021-10-19T12:09:28.037" v="540" actId="1037"/>
          <ac:cxnSpMkLst>
            <pc:docMk/>
            <pc:sldMk cId="3950835867" sldId="257"/>
            <ac:cxnSpMk id="7" creationId="{6AE06585-A0A2-4E50-8C64-56EC949BB935}"/>
          </ac:cxnSpMkLst>
        </pc:cxnChg>
        <pc:cxnChg chg="mod">
          <ac:chgData name="emanueleci hotmail.it" userId="e89a963879081f48" providerId="LiveId" clId="{859B42AE-FF30-483C-8862-A36516484D75}" dt="2021-10-19T12:09:28.037" v="540" actId="1037"/>
          <ac:cxnSpMkLst>
            <pc:docMk/>
            <pc:sldMk cId="3950835867" sldId="257"/>
            <ac:cxnSpMk id="9" creationId="{C7DCC1AC-1F38-4A0D-A53E-B7B90E8CC770}"/>
          </ac:cxnSpMkLst>
        </pc:cxnChg>
        <pc:cxnChg chg="mod">
          <ac:chgData name="emanueleci hotmail.it" userId="e89a963879081f48" providerId="LiveId" clId="{859B42AE-FF30-483C-8862-A36516484D75}" dt="2021-10-19T12:09:28.037" v="540" actId="1037"/>
          <ac:cxnSpMkLst>
            <pc:docMk/>
            <pc:sldMk cId="3950835867" sldId="257"/>
            <ac:cxnSpMk id="13" creationId="{3694670B-F965-4674-A6F2-F877EA55BD88}"/>
          </ac:cxnSpMkLst>
        </pc:cxnChg>
        <pc:cxnChg chg="mod">
          <ac:chgData name="emanueleci hotmail.it" userId="e89a963879081f48" providerId="LiveId" clId="{859B42AE-FF30-483C-8862-A36516484D75}" dt="2021-10-19T12:09:28.037" v="540" actId="1037"/>
          <ac:cxnSpMkLst>
            <pc:docMk/>
            <pc:sldMk cId="3950835867" sldId="257"/>
            <ac:cxnSpMk id="17" creationId="{E118C851-1C5D-4F51-8FE0-5B5CFEB361F4}"/>
          </ac:cxnSpMkLst>
        </pc:cxnChg>
        <pc:cxnChg chg="mod">
          <ac:chgData name="emanueleci hotmail.it" userId="e89a963879081f48" providerId="LiveId" clId="{859B42AE-FF30-483C-8862-A36516484D75}" dt="2021-10-19T12:09:39.835" v="546" actId="1038"/>
          <ac:cxnSpMkLst>
            <pc:docMk/>
            <pc:sldMk cId="3950835867" sldId="257"/>
            <ac:cxnSpMk id="20" creationId="{07509CAC-67A6-405D-9FAE-F3591B8A2821}"/>
          </ac:cxnSpMkLst>
        </pc:cxnChg>
        <pc:cxnChg chg="mod">
          <ac:chgData name="emanueleci hotmail.it" userId="e89a963879081f48" providerId="LiveId" clId="{859B42AE-FF30-483C-8862-A36516484D75}" dt="2021-10-19T12:09:28.037" v="540" actId="1037"/>
          <ac:cxnSpMkLst>
            <pc:docMk/>
            <pc:sldMk cId="3950835867" sldId="257"/>
            <ac:cxnSpMk id="22" creationId="{2EBF281C-D0EA-426A-B1D9-C38A91455AEC}"/>
          </ac:cxnSpMkLst>
        </pc:cxnChg>
        <pc:cxnChg chg="del mod">
          <ac:chgData name="emanueleci hotmail.it" userId="e89a963879081f48" providerId="LiveId" clId="{859B42AE-FF30-483C-8862-A36516484D75}" dt="2021-10-19T12:08:44.894" v="489" actId="478"/>
          <ac:cxnSpMkLst>
            <pc:docMk/>
            <pc:sldMk cId="3950835867" sldId="257"/>
            <ac:cxnSpMk id="25" creationId="{8542BA9A-7723-46FE-8C40-30199510C106}"/>
          </ac:cxnSpMkLst>
        </pc:cxnChg>
        <pc:cxnChg chg="del">
          <ac:chgData name="emanueleci hotmail.it" userId="e89a963879081f48" providerId="LiveId" clId="{859B42AE-FF30-483C-8862-A36516484D75}" dt="2021-10-19T12:08:46.878" v="490" actId="478"/>
          <ac:cxnSpMkLst>
            <pc:docMk/>
            <pc:sldMk cId="3950835867" sldId="257"/>
            <ac:cxnSpMk id="28" creationId="{F1CF55BF-8577-46C0-8A08-19563505FB8B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F73F2EA-04BE-4FB2-8C2D-3CEEE284AC6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7115B860-D114-449B-8DD2-1B385EA70E1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0D8AE85-925D-480D-A808-1AACAACE64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ADB76-071D-44CA-8569-207161ADC5FF}" type="datetimeFigureOut">
              <a:rPr lang="it-IT" smtClean="0"/>
              <a:t>19/10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4867E7A-F756-42D2-A621-6BB269DB2C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3792BF0-F4B7-4D45-B001-CE5FDA071D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37895-0D4F-4CCF-9583-D4532818552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017796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E69906E-B7B0-4D20-BE0A-F574EB0D90C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F3F9C49C-0331-42F8-9680-CC004FD9EB3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7B7DBFD-16AA-4E08-8287-A44DF13F90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ADB76-071D-44CA-8569-207161ADC5FF}" type="datetimeFigureOut">
              <a:rPr lang="it-IT" smtClean="0"/>
              <a:t>19/10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467A094-5CC1-4D77-BBE1-2241E70DA4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9B946FA-F2D6-4B88-9784-2E5A8574DC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37895-0D4F-4CCF-9583-D4532818552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317526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8755EDD3-9871-45CF-8681-6A315A255C2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D07B2038-F3F9-4489-AF3B-AE96302BDFA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E554D44-8B26-4F9D-A8B2-D738F31A47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ADB76-071D-44CA-8569-207161ADC5FF}" type="datetimeFigureOut">
              <a:rPr lang="it-IT" smtClean="0"/>
              <a:t>19/10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8666A55-D673-4B8D-99CA-AB387D6B2A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BD96DC0-C499-492E-9EB0-9918B66B6C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37895-0D4F-4CCF-9583-D4532818552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188926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2617B79-B903-4A89-8738-47467A62D4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9977ECFE-29BB-499E-9A31-648768E1D48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8345151-7EFC-4CBD-B564-8C5138838E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ADB76-071D-44CA-8569-207161ADC5FF}" type="datetimeFigureOut">
              <a:rPr lang="it-IT" smtClean="0"/>
              <a:t>19/10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ADA4DA9B-1C0F-406B-81E6-C7E75980CA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3E45615-DC12-4A44-95A9-613B7E7171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37895-0D4F-4CCF-9583-D4532818552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710151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8513536-11AA-423E-B0AB-88D800784A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3E2F96ED-489C-497D-A288-C55D583348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8D2A8F9-1488-437C-A1D4-BFC817B5C8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ADB76-071D-44CA-8569-207161ADC5FF}" type="datetimeFigureOut">
              <a:rPr lang="it-IT" smtClean="0"/>
              <a:t>19/10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F020214-D856-46F2-9AFA-C70FAA79B7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78BD509-8FC6-480C-8A62-9C903AC73F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37895-0D4F-4CCF-9583-D4532818552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211947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18E4A90-E4AB-4233-B2E6-9BE9722D0E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1B977247-9B46-44EB-B08A-16618A6AB77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BB1EEAA1-488D-48E1-9FEC-BC9FEF3A0B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4FE47D27-A062-4F4D-8D41-FA09631485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ADB76-071D-44CA-8569-207161ADC5FF}" type="datetimeFigureOut">
              <a:rPr lang="it-IT" smtClean="0"/>
              <a:t>19/10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70D9B1A4-25D7-4BA4-9950-68DD535105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DD460DAD-C903-4556-A157-FED9B106D8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37895-0D4F-4CCF-9583-D4532818552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379214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BDFFE6C-48DA-437F-BF40-977C8DD561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3BFA4115-FDFC-4BA9-8AA8-7A4C626873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17EC74A2-6A83-45CF-91E5-4399118ED15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844261CA-E331-4187-8FFD-94AEF614BBF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2F1B708B-C260-41D7-8F8F-C583D4D9400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C0C37070-E74B-41E8-96C4-E4D5283AAB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ADB76-071D-44CA-8569-207161ADC5FF}" type="datetimeFigureOut">
              <a:rPr lang="it-IT" smtClean="0"/>
              <a:t>19/10/2021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220C2337-517D-4955-A585-C1662C766B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A3E264FD-FDEF-4DD6-AF1D-0D29CE5238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37895-0D4F-4CCF-9583-D4532818552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716180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23D42FF-3DE7-4B29-8646-371D2DEF47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8A0DB07E-CEEB-47B5-9B1F-6811F0AD14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ADB76-071D-44CA-8569-207161ADC5FF}" type="datetimeFigureOut">
              <a:rPr lang="it-IT" smtClean="0"/>
              <a:t>19/10/2021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3B4ACAE5-710B-4D4C-B6F8-9FA80301A9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2094773E-3FDF-4608-9949-A795757E2C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37895-0D4F-4CCF-9583-D4532818552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476345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EE46A8A2-7C5F-42DA-BDB3-F3CA6513CA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ADB76-071D-44CA-8569-207161ADC5FF}" type="datetimeFigureOut">
              <a:rPr lang="it-IT" smtClean="0"/>
              <a:t>19/10/2021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546E5A3B-61A1-4301-A861-CCC89551E3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DC9A3F37-8A2E-4A84-A067-C4FCB72FBB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37895-0D4F-4CCF-9583-D4532818552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809637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ECBD6A3-842C-46E6-B8DA-B8BF972440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E6C24885-F39B-488D-894E-6461A4A6990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59FF25FA-2C80-4A3E-A723-B688FA2DA25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2CB76F6D-02D4-41B1-8A1A-44D3865E40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ADB76-071D-44CA-8569-207161ADC5FF}" type="datetimeFigureOut">
              <a:rPr lang="it-IT" smtClean="0"/>
              <a:t>19/10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B8BCD866-2C94-4C99-89CA-E39C497755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A228C2AB-C14C-4696-8515-37D1845F2E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37895-0D4F-4CCF-9583-D4532818552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027803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A60AF82-5DAC-4A63-9617-9069A0F37F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095ECC8B-5899-4418-9D29-F75E0DCB2E4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1942A4C4-E400-4A81-9334-47DA16F813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4BBFFF44-4E6A-465C-A7AA-2953253C41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DADB76-071D-44CA-8569-207161ADC5FF}" type="datetimeFigureOut">
              <a:rPr lang="it-IT" smtClean="0"/>
              <a:t>19/10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98848B74-6FD5-4F59-939A-37B9E5DDE3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FF46F2E2-BF39-44BF-AE21-627BB4A492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E37895-0D4F-4CCF-9583-D4532818552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09003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53D6E2C4-97DC-46A3-B253-E0630D8022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4BE930BB-1ECF-47BE-9AAF-77BC6E76C2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ED5FCE15-BF9A-492C-9E08-42CF6280337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DADB76-071D-44CA-8569-207161ADC5FF}" type="datetimeFigureOut">
              <a:rPr lang="it-IT" smtClean="0"/>
              <a:t>19/10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18F09BB-3514-4EB6-AD2C-E6F9EBB7F88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3725ED2-AB33-4472-9A30-14D0F951676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E37895-0D4F-4CCF-9583-D4532818552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637311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ttangolo 4">
            <a:extLst>
              <a:ext uri="{FF2B5EF4-FFF2-40B4-BE49-F238E27FC236}">
                <a16:creationId xmlns:a16="http://schemas.microsoft.com/office/drawing/2014/main" id="{81EAEBF6-1D89-4BBD-91AE-618237EC63AA}"/>
              </a:ext>
            </a:extLst>
          </p:cNvPr>
          <p:cNvSpPr/>
          <p:nvPr/>
        </p:nvSpPr>
        <p:spPr>
          <a:xfrm>
            <a:off x="1206935" y="1037825"/>
            <a:ext cx="2884602" cy="602663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>
              <a:solidFill>
                <a:schemeClr val="tx1"/>
              </a:solidFill>
            </a:endParaRPr>
          </a:p>
          <a:p>
            <a:pPr algn="ctr"/>
            <a:r>
              <a:rPr lang="it-IT" dirty="0">
                <a:solidFill>
                  <a:schemeClr val="tx1"/>
                </a:solidFill>
              </a:rPr>
              <a:t>601 </a:t>
            </a:r>
            <a:r>
              <a:rPr lang="it-IT" dirty="0" err="1">
                <a:solidFill>
                  <a:schemeClr val="tx1"/>
                </a:solidFill>
              </a:rPr>
              <a:t>confirmed</a:t>
            </a:r>
            <a:r>
              <a:rPr lang="it-IT" dirty="0">
                <a:solidFill>
                  <a:schemeClr val="tx1"/>
                </a:solidFill>
              </a:rPr>
              <a:t> GGE </a:t>
            </a:r>
            <a:r>
              <a:rPr lang="it-IT" dirty="0" err="1">
                <a:solidFill>
                  <a:schemeClr val="tx1"/>
                </a:solidFill>
              </a:rPr>
              <a:t>patients</a:t>
            </a:r>
            <a:r>
              <a:rPr lang="it-IT" dirty="0">
                <a:solidFill>
                  <a:schemeClr val="tx1"/>
                </a:solidFill>
              </a:rPr>
              <a:t> 	</a:t>
            </a:r>
          </a:p>
        </p:txBody>
      </p:sp>
      <p:cxnSp>
        <p:nvCxnSpPr>
          <p:cNvPr id="7" name="Connettore 2 6">
            <a:extLst>
              <a:ext uri="{FF2B5EF4-FFF2-40B4-BE49-F238E27FC236}">
                <a16:creationId xmlns:a16="http://schemas.microsoft.com/office/drawing/2014/main" id="{6AE06585-A0A2-4E50-8C64-56EC949BB935}"/>
              </a:ext>
            </a:extLst>
          </p:cNvPr>
          <p:cNvCxnSpPr>
            <a:cxnSpLocks/>
          </p:cNvCxnSpPr>
          <p:nvPr/>
        </p:nvCxnSpPr>
        <p:spPr>
          <a:xfrm>
            <a:off x="2536065" y="1647485"/>
            <a:ext cx="5583" cy="68001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Rettangolo 7">
            <a:extLst>
              <a:ext uri="{FF2B5EF4-FFF2-40B4-BE49-F238E27FC236}">
                <a16:creationId xmlns:a16="http://schemas.microsoft.com/office/drawing/2014/main" id="{2162AF28-BB35-464A-993B-2E62FF24715D}"/>
              </a:ext>
            </a:extLst>
          </p:cNvPr>
          <p:cNvSpPr/>
          <p:nvPr/>
        </p:nvSpPr>
        <p:spPr>
          <a:xfrm>
            <a:off x="1211934" y="2338121"/>
            <a:ext cx="2884602" cy="647188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dirty="0">
                <a:solidFill>
                  <a:schemeClr val="tx1"/>
                </a:solidFill>
              </a:rPr>
              <a:t>274 </a:t>
            </a:r>
            <a:r>
              <a:rPr lang="it-IT" dirty="0" err="1">
                <a:solidFill>
                  <a:schemeClr val="tx1"/>
                </a:solidFill>
              </a:rPr>
              <a:t>pts</a:t>
            </a:r>
            <a:endParaRPr lang="it-IT" dirty="0">
              <a:solidFill>
                <a:schemeClr val="tx1"/>
              </a:solidFill>
            </a:endParaRPr>
          </a:p>
        </p:txBody>
      </p:sp>
      <p:cxnSp>
        <p:nvCxnSpPr>
          <p:cNvPr id="9" name="Connettore 2 8">
            <a:extLst>
              <a:ext uri="{FF2B5EF4-FFF2-40B4-BE49-F238E27FC236}">
                <a16:creationId xmlns:a16="http://schemas.microsoft.com/office/drawing/2014/main" id="{C7DCC1AC-1F38-4A0D-A53E-B7B90E8CC770}"/>
              </a:ext>
            </a:extLst>
          </p:cNvPr>
          <p:cNvCxnSpPr>
            <a:cxnSpLocks/>
          </p:cNvCxnSpPr>
          <p:nvPr/>
        </p:nvCxnSpPr>
        <p:spPr>
          <a:xfrm>
            <a:off x="2556657" y="1996796"/>
            <a:ext cx="249024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CasellaDiTesto 10">
            <a:extLst>
              <a:ext uri="{FF2B5EF4-FFF2-40B4-BE49-F238E27FC236}">
                <a16:creationId xmlns:a16="http://schemas.microsoft.com/office/drawing/2014/main" id="{A8AD9E5E-4582-4C2A-9F45-8E77747EA968}"/>
              </a:ext>
            </a:extLst>
          </p:cNvPr>
          <p:cNvSpPr txBox="1"/>
          <p:nvPr/>
        </p:nvSpPr>
        <p:spPr>
          <a:xfrm>
            <a:off x="3249697" y="1665663"/>
            <a:ext cx="12349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/>
              <a:t>Excluded</a:t>
            </a:r>
            <a:endParaRPr lang="it-IT" dirty="0"/>
          </a:p>
        </p:txBody>
      </p:sp>
      <p:sp>
        <p:nvSpPr>
          <p:cNvPr id="12" name="Rettangolo 11">
            <a:extLst>
              <a:ext uri="{FF2B5EF4-FFF2-40B4-BE49-F238E27FC236}">
                <a16:creationId xmlns:a16="http://schemas.microsoft.com/office/drawing/2014/main" id="{E6597CF4-016B-4366-8883-E0C0B3363FFD}"/>
              </a:ext>
            </a:extLst>
          </p:cNvPr>
          <p:cNvSpPr/>
          <p:nvPr/>
        </p:nvSpPr>
        <p:spPr>
          <a:xfrm>
            <a:off x="5143044" y="1729037"/>
            <a:ext cx="2659932" cy="570063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dirty="0">
                <a:solidFill>
                  <a:schemeClr val="tx1"/>
                </a:solidFill>
              </a:rPr>
              <a:t>327 </a:t>
            </a:r>
            <a:r>
              <a:rPr lang="it-IT" dirty="0" err="1">
                <a:solidFill>
                  <a:schemeClr val="tx1"/>
                </a:solidFill>
              </a:rPr>
              <a:t>pts</a:t>
            </a:r>
            <a:r>
              <a:rPr lang="it-IT" dirty="0">
                <a:solidFill>
                  <a:schemeClr val="tx1"/>
                </a:solidFill>
              </a:rPr>
              <a:t> </a:t>
            </a:r>
            <a:r>
              <a:rPr lang="it-IT" dirty="0" err="1">
                <a:solidFill>
                  <a:schemeClr val="tx1"/>
                </a:solidFill>
              </a:rPr>
              <a:t>without</a:t>
            </a:r>
            <a:r>
              <a:rPr lang="it-IT" dirty="0">
                <a:solidFill>
                  <a:schemeClr val="tx1"/>
                </a:solidFill>
              </a:rPr>
              <a:t> </a:t>
            </a:r>
            <a:r>
              <a:rPr lang="it-IT" dirty="0" err="1">
                <a:solidFill>
                  <a:schemeClr val="tx1"/>
                </a:solidFill>
              </a:rPr>
              <a:t>paEEG</a:t>
            </a:r>
            <a:endParaRPr lang="it-IT" dirty="0">
              <a:solidFill>
                <a:schemeClr val="tx1"/>
              </a:solidFill>
            </a:endParaRPr>
          </a:p>
        </p:txBody>
      </p:sp>
      <p:cxnSp>
        <p:nvCxnSpPr>
          <p:cNvPr id="13" name="Connettore 2 12">
            <a:extLst>
              <a:ext uri="{FF2B5EF4-FFF2-40B4-BE49-F238E27FC236}">
                <a16:creationId xmlns:a16="http://schemas.microsoft.com/office/drawing/2014/main" id="{3694670B-F965-4674-A6F2-F877EA55BD88}"/>
              </a:ext>
            </a:extLst>
          </p:cNvPr>
          <p:cNvCxnSpPr>
            <a:cxnSpLocks/>
          </p:cNvCxnSpPr>
          <p:nvPr/>
        </p:nvCxnSpPr>
        <p:spPr>
          <a:xfrm>
            <a:off x="2511262" y="2988406"/>
            <a:ext cx="0" cy="68613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Rettangolo 13">
            <a:extLst>
              <a:ext uri="{FF2B5EF4-FFF2-40B4-BE49-F238E27FC236}">
                <a16:creationId xmlns:a16="http://schemas.microsoft.com/office/drawing/2014/main" id="{C225EE38-EA76-4EA0-A9A2-56B5DBF896AD}"/>
              </a:ext>
            </a:extLst>
          </p:cNvPr>
          <p:cNvSpPr/>
          <p:nvPr/>
        </p:nvSpPr>
        <p:spPr>
          <a:xfrm>
            <a:off x="1164228" y="3699969"/>
            <a:ext cx="2932308" cy="687253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dirty="0">
                <a:solidFill>
                  <a:schemeClr val="tx1"/>
                </a:solidFill>
              </a:rPr>
              <a:t>227 </a:t>
            </a:r>
            <a:r>
              <a:rPr lang="it-IT" dirty="0" err="1">
                <a:solidFill>
                  <a:schemeClr val="tx1"/>
                </a:solidFill>
              </a:rPr>
              <a:t>pts</a:t>
            </a:r>
            <a:endParaRPr lang="it-IT" dirty="0">
              <a:solidFill>
                <a:schemeClr val="tx1"/>
              </a:solidFill>
            </a:endParaRPr>
          </a:p>
        </p:txBody>
      </p:sp>
      <p:cxnSp>
        <p:nvCxnSpPr>
          <p:cNvPr id="17" name="Connettore 2 16">
            <a:extLst>
              <a:ext uri="{FF2B5EF4-FFF2-40B4-BE49-F238E27FC236}">
                <a16:creationId xmlns:a16="http://schemas.microsoft.com/office/drawing/2014/main" id="{E118C851-1C5D-4F51-8FE0-5B5CFEB361F4}"/>
              </a:ext>
            </a:extLst>
          </p:cNvPr>
          <p:cNvCxnSpPr>
            <a:cxnSpLocks/>
          </p:cNvCxnSpPr>
          <p:nvPr/>
        </p:nvCxnSpPr>
        <p:spPr>
          <a:xfrm>
            <a:off x="2536065" y="3318184"/>
            <a:ext cx="249024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36FA1397-129F-4530-8186-71522C769539}"/>
              </a:ext>
            </a:extLst>
          </p:cNvPr>
          <p:cNvSpPr txBox="1"/>
          <p:nvPr/>
        </p:nvSpPr>
        <p:spPr>
          <a:xfrm>
            <a:off x="3163733" y="2988406"/>
            <a:ext cx="12349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/>
              <a:t>Excluded</a:t>
            </a:r>
            <a:endParaRPr lang="it-IT" dirty="0"/>
          </a:p>
        </p:txBody>
      </p:sp>
      <p:sp>
        <p:nvSpPr>
          <p:cNvPr id="19" name="Rettangolo 18">
            <a:extLst>
              <a:ext uri="{FF2B5EF4-FFF2-40B4-BE49-F238E27FC236}">
                <a16:creationId xmlns:a16="http://schemas.microsoft.com/office/drawing/2014/main" id="{6DD693FF-8D0C-4FC3-B9B6-674F3ECF1E16}"/>
              </a:ext>
            </a:extLst>
          </p:cNvPr>
          <p:cNvSpPr/>
          <p:nvPr/>
        </p:nvSpPr>
        <p:spPr>
          <a:xfrm>
            <a:off x="5067497" y="2992507"/>
            <a:ext cx="2703922" cy="570063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dirty="0">
                <a:solidFill>
                  <a:schemeClr val="tx1"/>
                </a:solidFill>
              </a:rPr>
              <a:t>47 </a:t>
            </a:r>
            <a:r>
              <a:rPr lang="it-IT" dirty="0" err="1">
                <a:solidFill>
                  <a:schemeClr val="tx1"/>
                </a:solidFill>
              </a:rPr>
              <a:t>pts</a:t>
            </a:r>
            <a:r>
              <a:rPr lang="it-IT" dirty="0">
                <a:solidFill>
                  <a:schemeClr val="tx1"/>
                </a:solidFill>
              </a:rPr>
              <a:t> with </a:t>
            </a:r>
            <a:r>
              <a:rPr lang="it-IT" dirty="0" err="1">
                <a:solidFill>
                  <a:schemeClr val="tx1"/>
                </a:solidFill>
              </a:rPr>
              <a:t>inadequate</a:t>
            </a:r>
            <a:r>
              <a:rPr lang="it-IT" dirty="0">
                <a:solidFill>
                  <a:schemeClr val="tx1"/>
                </a:solidFill>
              </a:rPr>
              <a:t> follow-up duration</a:t>
            </a:r>
          </a:p>
        </p:txBody>
      </p:sp>
      <p:cxnSp>
        <p:nvCxnSpPr>
          <p:cNvPr id="20" name="Connettore 2 19">
            <a:extLst>
              <a:ext uri="{FF2B5EF4-FFF2-40B4-BE49-F238E27FC236}">
                <a16:creationId xmlns:a16="http://schemas.microsoft.com/office/drawing/2014/main" id="{07509CAC-67A6-405D-9FAE-F3591B8A2821}"/>
              </a:ext>
            </a:extLst>
          </p:cNvPr>
          <p:cNvCxnSpPr>
            <a:cxnSpLocks/>
          </p:cNvCxnSpPr>
          <p:nvPr/>
        </p:nvCxnSpPr>
        <p:spPr>
          <a:xfrm>
            <a:off x="2514998" y="4387222"/>
            <a:ext cx="0" cy="62311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Rettangolo 20">
            <a:extLst>
              <a:ext uri="{FF2B5EF4-FFF2-40B4-BE49-F238E27FC236}">
                <a16:creationId xmlns:a16="http://schemas.microsoft.com/office/drawing/2014/main" id="{A7119A6D-170B-4B36-99D4-8C6C803C57B9}"/>
              </a:ext>
            </a:extLst>
          </p:cNvPr>
          <p:cNvSpPr/>
          <p:nvPr/>
        </p:nvSpPr>
        <p:spPr>
          <a:xfrm>
            <a:off x="1244642" y="5011415"/>
            <a:ext cx="2884602" cy="648362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>
                <a:solidFill>
                  <a:schemeClr val="tx1"/>
                </a:solidFill>
              </a:rPr>
              <a:t> 201 </a:t>
            </a:r>
            <a:r>
              <a:rPr lang="it-IT" dirty="0" err="1">
                <a:solidFill>
                  <a:schemeClr val="tx1"/>
                </a:solidFill>
              </a:rPr>
              <a:t>pts</a:t>
            </a:r>
            <a:endParaRPr lang="it-IT" dirty="0">
              <a:solidFill>
                <a:schemeClr val="tx1"/>
              </a:solidFill>
            </a:endParaRPr>
          </a:p>
        </p:txBody>
      </p:sp>
      <p:cxnSp>
        <p:nvCxnSpPr>
          <p:cNvPr id="22" name="Connettore 2 21">
            <a:extLst>
              <a:ext uri="{FF2B5EF4-FFF2-40B4-BE49-F238E27FC236}">
                <a16:creationId xmlns:a16="http://schemas.microsoft.com/office/drawing/2014/main" id="{2EBF281C-D0EA-426A-B1D9-C38A91455AEC}"/>
              </a:ext>
            </a:extLst>
          </p:cNvPr>
          <p:cNvCxnSpPr>
            <a:cxnSpLocks/>
          </p:cNvCxnSpPr>
          <p:nvPr/>
        </p:nvCxnSpPr>
        <p:spPr>
          <a:xfrm>
            <a:off x="2536065" y="4671713"/>
            <a:ext cx="2531432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CasellaDiTesto 22">
            <a:extLst>
              <a:ext uri="{FF2B5EF4-FFF2-40B4-BE49-F238E27FC236}">
                <a16:creationId xmlns:a16="http://schemas.microsoft.com/office/drawing/2014/main" id="{BEB0BD55-8E2B-4C50-B577-FA9531DAB4B0}"/>
              </a:ext>
            </a:extLst>
          </p:cNvPr>
          <p:cNvSpPr txBox="1"/>
          <p:nvPr/>
        </p:nvSpPr>
        <p:spPr>
          <a:xfrm>
            <a:off x="3299974" y="4387222"/>
            <a:ext cx="12553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err="1"/>
              <a:t>Excluded</a:t>
            </a:r>
            <a:endParaRPr lang="it-IT" dirty="0"/>
          </a:p>
        </p:txBody>
      </p:sp>
      <p:sp>
        <p:nvSpPr>
          <p:cNvPr id="24" name="Rettangolo 23">
            <a:extLst>
              <a:ext uri="{FF2B5EF4-FFF2-40B4-BE49-F238E27FC236}">
                <a16:creationId xmlns:a16="http://schemas.microsoft.com/office/drawing/2014/main" id="{60A4D4A5-FB85-4C28-A698-F2701941E4BB}"/>
              </a:ext>
            </a:extLst>
          </p:cNvPr>
          <p:cNvSpPr/>
          <p:nvPr/>
        </p:nvSpPr>
        <p:spPr>
          <a:xfrm>
            <a:off x="5067497" y="4387222"/>
            <a:ext cx="2703922" cy="872935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dirty="0">
                <a:solidFill>
                  <a:schemeClr val="tx1"/>
                </a:solidFill>
              </a:rPr>
              <a:t>26 </a:t>
            </a:r>
            <a:r>
              <a:rPr lang="it-IT" dirty="0" err="1">
                <a:solidFill>
                  <a:schemeClr val="tx1"/>
                </a:solidFill>
              </a:rPr>
              <a:t>pts</a:t>
            </a:r>
            <a:r>
              <a:rPr lang="it-IT" dirty="0">
                <a:solidFill>
                  <a:schemeClr val="tx1"/>
                </a:solidFill>
              </a:rPr>
              <a:t> with incomplete </a:t>
            </a:r>
            <a:r>
              <a:rPr lang="it-IT" dirty="0" err="1">
                <a:solidFill>
                  <a:schemeClr val="tx1"/>
                </a:solidFill>
              </a:rPr>
              <a:t>seizure</a:t>
            </a:r>
            <a:r>
              <a:rPr lang="it-IT" dirty="0">
                <a:solidFill>
                  <a:schemeClr val="tx1"/>
                </a:solidFill>
              </a:rPr>
              <a:t> </a:t>
            </a:r>
            <a:r>
              <a:rPr lang="it-IT" dirty="0" err="1">
                <a:solidFill>
                  <a:schemeClr val="tx1"/>
                </a:solidFill>
              </a:rPr>
              <a:t>outcome</a:t>
            </a:r>
            <a:r>
              <a:rPr lang="it-IT" dirty="0">
                <a:solidFill>
                  <a:schemeClr val="tx1"/>
                </a:solidFill>
              </a:rPr>
              <a:t> information</a:t>
            </a:r>
          </a:p>
        </p:txBody>
      </p:sp>
      <p:sp>
        <p:nvSpPr>
          <p:cNvPr id="30" name="CasellaDiTesto 29">
            <a:extLst>
              <a:ext uri="{FF2B5EF4-FFF2-40B4-BE49-F238E27FC236}">
                <a16:creationId xmlns:a16="http://schemas.microsoft.com/office/drawing/2014/main" id="{8A140BE8-0CCC-42C0-A108-2A7F94EF197B}"/>
              </a:ext>
            </a:extLst>
          </p:cNvPr>
          <p:cNvSpPr txBox="1"/>
          <p:nvPr/>
        </p:nvSpPr>
        <p:spPr>
          <a:xfrm>
            <a:off x="312012" y="38195"/>
            <a:ext cx="721793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it-IT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igure 1. </a:t>
            </a:r>
            <a:r>
              <a:rPr lang="it-IT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tients</a:t>
            </a:r>
            <a:r>
              <a:rPr lang="it-IT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’ </a:t>
            </a:r>
            <a:r>
              <a:rPr lang="it-IT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nrollment</a:t>
            </a:r>
            <a:r>
              <a:rPr lang="it-IT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6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thods</a:t>
            </a:r>
            <a:endParaRPr lang="it-IT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Rettangolo 3">
            <a:extLst>
              <a:ext uri="{FF2B5EF4-FFF2-40B4-BE49-F238E27FC236}">
                <a16:creationId xmlns:a16="http://schemas.microsoft.com/office/drawing/2014/main" id="{A42BFD2E-AC28-4C7A-9506-5456E9EEF41E}"/>
              </a:ext>
            </a:extLst>
          </p:cNvPr>
          <p:cNvSpPr/>
          <p:nvPr/>
        </p:nvSpPr>
        <p:spPr>
          <a:xfrm>
            <a:off x="599993" y="957378"/>
            <a:ext cx="7597302" cy="5127902"/>
          </a:xfrm>
          <a:prstGeom prst="rect">
            <a:avLst/>
          </a:prstGeom>
          <a:noFill/>
          <a:ln>
            <a:solidFill>
              <a:schemeClr val="bg1">
                <a:lumMod val="7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31" name="CasellaDiTesto 30">
            <a:extLst>
              <a:ext uri="{FF2B5EF4-FFF2-40B4-BE49-F238E27FC236}">
                <a16:creationId xmlns:a16="http://schemas.microsoft.com/office/drawing/2014/main" id="{13AE9D6E-0A99-4C08-A5F5-77938EDABF18}"/>
              </a:ext>
            </a:extLst>
          </p:cNvPr>
          <p:cNvSpPr txBox="1"/>
          <p:nvPr/>
        </p:nvSpPr>
        <p:spPr>
          <a:xfrm>
            <a:off x="8630518" y="948635"/>
            <a:ext cx="3239311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it-IT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gend</a:t>
            </a:r>
            <a:r>
              <a:rPr 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</a:t>
            </a:r>
            <a:r>
              <a:rPr lang="it-IT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bbreviations</a:t>
            </a:r>
            <a:r>
              <a:rPr 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GGE = </a:t>
            </a:r>
            <a:r>
              <a:rPr lang="it-IT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netic</a:t>
            </a:r>
            <a:r>
              <a:rPr 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eneralized</a:t>
            </a:r>
            <a:r>
              <a:rPr 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pilepsy</a:t>
            </a:r>
            <a:r>
              <a:rPr 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</a:t>
            </a:r>
            <a:r>
              <a:rPr lang="it-IT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EEG</a:t>
            </a:r>
            <a:r>
              <a:rPr 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</a:t>
            </a:r>
            <a:r>
              <a:rPr lang="it-IT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longed</a:t>
            </a:r>
            <a:r>
              <a:rPr 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mbulatory</a:t>
            </a:r>
            <a:r>
              <a:rPr lang="it-IT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EG;</a:t>
            </a:r>
          </a:p>
        </p:txBody>
      </p:sp>
    </p:spTree>
    <p:extLst>
      <p:ext uri="{BB962C8B-B14F-4D97-AF65-F5344CB8AC3E}">
        <p14:creationId xmlns:p14="http://schemas.microsoft.com/office/powerpoint/2010/main" val="395083586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57</Words>
  <Application>Microsoft Office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emanueleci hotmail.it</dc:creator>
  <cp:lastModifiedBy>emanueleci hotmail.it</cp:lastModifiedBy>
  <cp:revision>1</cp:revision>
  <dcterms:created xsi:type="dcterms:W3CDTF">2021-10-11T13:19:10Z</dcterms:created>
  <dcterms:modified xsi:type="dcterms:W3CDTF">2021-10-19T12:10:16Z</dcterms:modified>
</cp:coreProperties>
</file>